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9" r:id="rId3"/>
    <p:sldId id="264" r:id="rId4"/>
    <p:sldId id="262" r:id="rId5"/>
    <p:sldId id="257" r:id="rId6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 " initials="MSOffice" lastIdx="6" clrIdx="0">
    <p:extLst>
      <p:ext uri="{19B8F6BF-5375-455C-9EA6-DF929625EA0E}">
        <p15:presenceInfo xmlns:p15="http://schemas.microsoft.com/office/powerpoint/2012/main" userId=" 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3608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138" y="53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60181C-B13C-42FB-8649-BEFF87C82AB1}" type="datetimeFigureOut">
              <a:rPr lang="de-DE" smtClean="0"/>
              <a:t>10.05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9F6AA-5D45-4CF9-94D3-545B5DC4F55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179058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60181C-B13C-42FB-8649-BEFF87C82AB1}" type="datetimeFigureOut">
              <a:rPr lang="de-DE" smtClean="0"/>
              <a:t>10.05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9F6AA-5D45-4CF9-94D3-545B5DC4F55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089206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60181C-B13C-42FB-8649-BEFF87C82AB1}" type="datetimeFigureOut">
              <a:rPr lang="de-DE" smtClean="0"/>
              <a:t>10.05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9F6AA-5D45-4CF9-94D3-545B5DC4F55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702117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60181C-B13C-42FB-8649-BEFF87C82AB1}" type="datetimeFigureOut">
              <a:rPr lang="de-DE" smtClean="0"/>
              <a:t>10.05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9F6AA-5D45-4CF9-94D3-545B5DC4F55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092639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60181C-B13C-42FB-8649-BEFF87C82AB1}" type="datetimeFigureOut">
              <a:rPr lang="de-DE" smtClean="0"/>
              <a:t>10.05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9F6AA-5D45-4CF9-94D3-545B5DC4F55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164859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60181C-B13C-42FB-8649-BEFF87C82AB1}" type="datetimeFigureOut">
              <a:rPr lang="de-DE" smtClean="0"/>
              <a:t>10.05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9F6AA-5D45-4CF9-94D3-545B5DC4F55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448816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60181C-B13C-42FB-8649-BEFF87C82AB1}" type="datetimeFigureOut">
              <a:rPr lang="de-DE" smtClean="0"/>
              <a:t>10.05.2021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9F6AA-5D45-4CF9-94D3-545B5DC4F55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174956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60181C-B13C-42FB-8649-BEFF87C82AB1}" type="datetimeFigureOut">
              <a:rPr lang="de-DE" smtClean="0"/>
              <a:t>10.05.2021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9F6AA-5D45-4CF9-94D3-545B5DC4F55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821724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60181C-B13C-42FB-8649-BEFF87C82AB1}" type="datetimeFigureOut">
              <a:rPr lang="de-DE" smtClean="0"/>
              <a:t>10.05.2021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9F6AA-5D45-4CF9-94D3-545B5DC4F55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453085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60181C-B13C-42FB-8649-BEFF87C82AB1}" type="datetimeFigureOut">
              <a:rPr lang="de-DE" smtClean="0"/>
              <a:t>10.05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9F6AA-5D45-4CF9-94D3-545B5DC4F55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198210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60181C-B13C-42FB-8649-BEFF87C82AB1}" type="datetimeFigureOut">
              <a:rPr lang="de-DE" smtClean="0"/>
              <a:t>10.05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9F6AA-5D45-4CF9-94D3-545B5DC4F55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921472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60181C-B13C-42FB-8649-BEFF87C82AB1}" type="datetimeFigureOut">
              <a:rPr lang="de-DE" smtClean="0"/>
              <a:t>10.05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99F6AA-5D45-4CF9-94D3-545B5DC4F55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033849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20E40DB4-EA1C-9D4C-BC24-E975B62AD8B7}"/>
              </a:ext>
            </a:extLst>
          </p:cNvPr>
          <p:cNvSpPr txBox="1"/>
          <p:nvPr/>
        </p:nvSpPr>
        <p:spPr>
          <a:xfrm>
            <a:off x="222422" y="74138"/>
            <a:ext cx="40530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 S1</a:t>
            </a:r>
          </a:p>
        </p:txBody>
      </p:sp>
      <p:pic>
        <p:nvPicPr>
          <p:cNvPr id="5" name="Picture 2" descr="\\G80w2h\user\beckricar\Pictures\Storch\Rö-Th-anfang.jpg">
            <a:extLst>
              <a:ext uri="{FF2B5EF4-FFF2-40B4-BE49-F238E27FC236}">
                <a16:creationId xmlns:a16="http://schemas.microsoft.com/office/drawing/2014/main" id="{2FE9597E-6BC4-974E-9FEA-578177E61762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582029" y="563491"/>
            <a:ext cx="6294036" cy="59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Rechteck 5">
            <a:extLst>
              <a:ext uri="{FF2B5EF4-FFF2-40B4-BE49-F238E27FC236}">
                <a16:creationId xmlns:a16="http://schemas.microsoft.com/office/drawing/2014/main" id="{36BA7ACB-D2E2-6A4F-B2C3-9CC19E5509F3}"/>
              </a:ext>
            </a:extLst>
          </p:cNvPr>
          <p:cNvSpPr/>
          <p:nvPr/>
        </p:nvSpPr>
        <p:spPr>
          <a:xfrm>
            <a:off x="5043488" y="846138"/>
            <a:ext cx="1131887" cy="304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632166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feld 8">
            <a:extLst>
              <a:ext uri="{FF2B5EF4-FFF2-40B4-BE49-F238E27FC236}">
                <a16:creationId xmlns:a16="http://schemas.microsoft.com/office/drawing/2014/main" id="{5181059C-4109-0246-8A1F-C11DFCB9D505}"/>
              </a:ext>
            </a:extLst>
          </p:cNvPr>
          <p:cNvSpPr txBox="1"/>
          <p:nvPr/>
        </p:nvSpPr>
        <p:spPr>
          <a:xfrm>
            <a:off x="222422" y="74138"/>
            <a:ext cx="40530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 S2</a:t>
            </a:r>
          </a:p>
        </p:txBody>
      </p:sp>
      <p:pic>
        <p:nvPicPr>
          <p:cNvPr id="3" name="Grafik 3">
            <a:extLst>
              <a:ext uri="{FF2B5EF4-FFF2-40B4-BE49-F238E27FC236}">
                <a16:creationId xmlns:a16="http://schemas.microsoft.com/office/drawing/2014/main" id="{8DAB841A-60D8-4C4C-96AD-AC6757C457D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08213" y="563297"/>
            <a:ext cx="4930200" cy="5940000"/>
          </a:xfrm>
          <a:prstGeom prst="rect">
            <a:avLst/>
          </a:prstGeom>
        </p:spPr>
      </p:pic>
      <p:sp>
        <p:nvSpPr>
          <p:cNvPr id="2" name="Textfeld 1">
            <a:extLst>
              <a:ext uri="{FF2B5EF4-FFF2-40B4-BE49-F238E27FC236}">
                <a16:creationId xmlns:a16="http://schemas.microsoft.com/office/drawing/2014/main" id="{EA853A9C-D50C-5B40-9939-9FD8E9F7FD57}"/>
              </a:ext>
            </a:extLst>
          </p:cNvPr>
          <p:cNvSpPr txBox="1"/>
          <p:nvPr/>
        </p:nvSpPr>
        <p:spPr>
          <a:xfrm>
            <a:off x="408213" y="563297"/>
            <a:ext cx="75237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dirty="0">
                <a:solidFill>
                  <a:schemeClr val="bg1"/>
                </a:solidFill>
              </a:rPr>
              <a:t>R</a:t>
            </a:r>
            <a:endParaRPr lang="de-DE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229963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1" name="Gruppieren 30"/>
          <p:cNvGrpSpPr/>
          <p:nvPr/>
        </p:nvGrpSpPr>
        <p:grpSpPr>
          <a:xfrm>
            <a:off x="4490223" y="3500689"/>
            <a:ext cx="3336346" cy="3240000"/>
            <a:chOff x="6475736" y="118446"/>
            <a:chExt cx="3336346" cy="3240000"/>
          </a:xfrm>
        </p:grpSpPr>
        <p:grpSp>
          <p:nvGrpSpPr>
            <p:cNvPr id="30" name="Gruppieren 29"/>
            <p:cNvGrpSpPr/>
            <p:nvPr/>
          </p:nvGrpSpPr>
          <p:grpSpPr>
            <a:xfrm>
              <a:off x="6475736" y="118446"/>
              <a:ext cx="3336346" cy="3240000"/>
              <a:chOff x="6475736" y="118446"/>
              <a:chExt cx="3336346" cy="3240000"/>
            </a:xfrm>
          </p:grpSpPr>
          <p:pic>
            <p:nvPicPr>
              <p:cNvPr id="16" name="Grafik 15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479511" y="118446"/>
                <a:ext cx="3332571" cy="3240000"/>
              </a:xfrm>
              <a:prstGeom prst="rect">
                <a:avLst/>
              </a:prstGeom>
            </p:spPr>
          </p:pic>
          <p:sp>
            <p:nvSpPr>
              <p:cNvPr id="18" name="Textfeld 17"/>
              <p:cNvSpPr txBox="1"/>
              <p:nvPr/>
            </p:nvSpPr>
            <p:spPr>
              <a:xfrm>
                <a:off x="6475736" y="118446"/>
                <a:ext cx="3332571" cy="37296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TPN13</a:t>
                </a:r>
                <a:endParaRPr lang="de-DE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20" name="Gerader Verbinder 19"/>
            <p:cNvCxnSpPr/>
            <p:nvPr/>
          </p:nvCxnSpPr>
          <p:spPr>
            <a:xfrm flipH="1">
              <a:off x="8027677" y="665701"/>
              <a:ext cx="0" cy="216000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" name="Textfeld 3"/>
          <p:cNvSpPr txBox="1"/>
          <p:nvPr/>
        </p:nvSpPr>
        <p:spPr>
          <a:xfrm>
            <a:off x="222422" y="189470"/>
            <a:ext cx="40530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S3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7" name="Gruppieren 26"/>
          <p:cNvGrpSpPr/>
          <p:nvPr/>
        </p:nvGrpSpPr>
        <p:grpSpPr>
          <a:xfrm>
            <a:off x="8361575" y="3493656"/>
            <a:ext cx="3332571" cy="3240000"/>
            <a:chOff x="4517543" y="3513001"/>
            <a:chExt cx="3332571" cy="3240000"/>
          </a:xfrm>
        </p:grpSpPr>
        <p:grpSp>
          <p:nvGrpSpPr>
            <p:cNvPr id="24" name="Gruppieren 23"/>
            <p:cNvGrpSpPr/>
            <p:nvPr/>
          </p:nvGrpSpPr>
          <p:grpSpPr>
            <a:xfrm>
              <a:off x="4517543" y="3513001"/>
              <a:ext cx="3332571" cy="3240000"/>
              <a:chOff x="4517543" y="3513001"/>
              <a:chExt cx="3332571" cy="3240000"/>
            </a:xfrm>
          </p:grpSpPr>
          <p:pic>
            <p:nvPicPr>
              <p:cNvPr id="6" name="Grafik 5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517543" y="3513001"/>
                <a:ext cx="3332571" cy="3240000"/>
              </a:xfrm>
              <a:prstGeom prst="rect">
                <a:avLst/>
              </a:prstGeom>
            </p:spPr>
          </p:pic>
          <p:cxnSp>
            <p:nvCxnSpPr>
              <p:cNvPr id="11" name="Gerader Verbinder 10"/>
              <p:cNvCxnSpPr/>
              <p:nvPr/>
            </p:nvCxnSpPr>
            <p:spPr>
              <a:xfrm flipH="1">
                <a:off x="7185241" y="4054543"/>
                <a:ext cx="0" cy="216000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" name="Textfeld 6"/>
            <p:cNvSpPr txBox="1"/>
            <p:nvPr/>
          </p:nvSpPr>
          <p:spPr>
            <a:xfrm>
              <a:off x="4517543" y="3523083"/>
              <a:ext cx="3269138" cy="3729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RMD9</a:t>
              </a:r>
              <a:endParaRPr lang="de-DE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9" name="Gruppieren 28"/>
          <p:cNvGrpSpPr/>
          <p:nvPr/>
        </p:nvGrpSpPr>
        <p:grpSpPr>
          <a:xfrm>
            <a:off x="6473244" y="127324"/>
            <a:ext cx="3332571" cy="3240000"/>
            <a:chOff x="506508" y="3513001"/>
            <a:chExt cx="3332571" cy="3240000"/>
          </a:xfrm>
        </p:grpSpPr>
        <p:grpSp>
          <p:nvGrpSpPr>
            <p:cNvPr id="23" name="Gruppieren 22"/>
            <p:cNvGrpSpPr/>
            <p:nvPr/>
          </p:nvGrpSpPr>
          <p:grpSpPr>
            <a:xfrm>
              <a:off x="506508" y="3513001"/>
              <a:ext cx="3332571" cy="3240000"/>
              <a:chOff x="506508" y="3513001"/>
              <a:chExt cx="3332571" cy="3240000"/>
            </a:xfrm>
          </p:grpSpPr>
          <p:pic>
            <p:nvPicPr>
              <p:cNvPr id="5" name="Grafik 4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06508" y="3513001"/>
                <a:ext cx="3332571" cy="3240000"/>
              </a:xfrm>
              <a:prstGeom prst="rect">
                <a:avLst/>
              </a:prstGeom>
            </p:spPr>
          </p:pic>
          <p:cxnSp>
            <p:nvCxnSpPr>
              <p:cNvPr id="10" name="Gerader Verbinder 9"/>
              <p:cNvCxnSpPr/>
              <p:nvPr/>
            </p:nvCxnSpPr>
            <p:spPr>
              <a:xfrm flipH="1">
                <a:off x="1136986" y="4061170"/>
                <a:ext cx="0" cy="216000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" name="Textfeld 7"/>
            <p:cNvSpPr txBox="1"/>
            <p:nvPr/>
          </p:nvSpPr>
          <p:spPr>
            <a:xfrm>
              <a:off x="506508" y="3523084"/>
              <a:ext cx="3332571" cy="3729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ANCC</a:t>
              </a:r>
              <a:endParaRPr lang="de-DE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8" name="Gruppieren 27"/>
          <p:cNvGrpSpPr/>
          <p:nvPr/>
        </p:nvGrpSpPr>
        <p:grpSpPr>
          <a:xfrm>
            <a:off x="622645" y="3500689"/>
            <a:ext cx="3332572" cy="3240000"/>
            <a:chOff x="8473426" y="3513001"/>
            <a:chExt cx="3332572" cy="3240000"/>
          </a:xfrm>
        </p:grpSpPr>
        <p:grpSp>
          <p:nvGrpSpPr>
            <p:cNvPr id="25" name="Gruppieren 24"/>
            <p:cNvGrpSpPr/>
            <p:nvPr/>
          </p:nvGrpSpPr>
          <p:grpSpPr>
            <a:xfrm>
              <a:off x="8473426" y="3513001"/>
              <a:ext cx="3332571" cy="3240000"/>
              <a:chOff x="8473426" y="3513001"/>
              <a:chExt cx="3332571" cy="3240000"/>
            </a:xfrm>
          </p:grpSpPr>
          <p:pic>
            <p:nvPicPr>
              <p:cNvPr id="12" name="Grafik 11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473426" y="3513001"/>
                <a:ext cx="3332571" cy="3240000"/>
              </a:xfrm>
              <a:prstGeom prst="rect">
                <a:avLst/>
              </a:prstGeom>
            </p:spPr>
          </p:pic>
          <p:cxnSp>
            <p:nvCxnSpPr>
              <p:cNvPr id="13" name="Gerader Verbinder 12"/>
              <p:cNvCxnSpPr/>
              <p:nvPr/>
            </p:nvCxnSpPr>
            <p:spPr>
              <a:xfrm flipH="1">
                <a:off x="10964706" y="4082768"/>
                <a:ext cx="0" cy="216000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" name="Textfeld 13"/>
            <p:cNvSpPr txBox="1"/>
            <p:nvPr/>
          </p:nvSpPr>
          <p:spPr>
            <a:xfrm>
              <a:off x="8473426" y="3523083"/>
              <a:ext cx="3332572" cy="3729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SC2</a:t>
              </a:r>
              <a:endParaRPr lang="de-DE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6" name="Gruppieren 25"/>
          <p:cNvGrpSpPr/>
          <p:nvPr/>
        </p:nvGrpSpPr>
        <p:grpSpPr>
          <a:xfrm>
            <a:off x="2511498" y="118446"/>
            <a:ext cx="3332571" cy="3240000"/>
            <a:chOff x="2511498" y="118446"/>
            <a:chExt cx="3332571" cy="3240000"/>
          </a:xfrm>
        </p:grpSpPr>
        <p:grpSp>
          <p:nvGrpSpPr>
            <p:cNvPr id="21" name="Gruppieren 20"/>
            <p:cNvGrpSpPr/>
            <p:nvPr/>
          </p:nvGrpSpPr>
          <p:grpSpPr>
            <a:xfrm>
              <a:off x="2511498" y="118446"/>
              <a:ext cx="3332571" cy="3240000"/>
              <a:chOff x="2511498" y="118446"/>
              <a:chExt cx="3332571" cy="3240000"/>
            </a:xfrm>
          </p:grpSpPr>
          <p:pic>
            <p:nvPicPr>
              <p:cNvPr id="15" name="Grafik 14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511498" y="118446"/>
                <a:ext cx="3332571" cy="3240000"/>
              </a:xfrm>
              <a:prstGeom prst="rect">
                <a:avLst/>
              </a:prstGeom>
            </p:spPr>
          </p:pic>
          <p:cxnSp>
            <p:nvCxnSpPr>
              <p:cNvPr id="19" name="Gerader Verbinder 18"/>
              <p:cNvCxnSpPr/>
              <p:nvPr/>
            </p:nvCxnSpPr>
            <p:spPr>
              <a:xfrm flipH="1">
                <a:off x="5275599" y="647296"/>
                <a:ext cx="0" cy="216000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7" name="Textfeld 16"/>
            <p:cNvSpPr txBox="1"/>
            <p:nvPr/>
          </p:nvSpPr>
          <p:spPr>
            <a:xfrm>
              <a:off x="2511498" y="127324"/>
              <a:ext cx="3332571" cy="3729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GFR</a:t>
              </a:r>
              <a:endParaRPr lang="de-DE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74934497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elle 5">
            <a:extLst>
              <a:ext uri="{FF2B5EF4-FFF2-40B4-BE49-F238E27FC236}">
                <a16:creationId xmlns:a16="http://schemas.microsoft.com/office/drawing/2014/main" id="{ABECFAEE-E0CE-FE40-BA95-D600C7DD466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0923230"/>
              </p:ext>
            </p:extLst>
          </p:nvPr>
        </p:nvGraphicFramePr>
        <p:xfrm>
          <a:off x="630206" y="750558"/>
          <a:ext cx="8130723" cy="5571076"/>
        </p:xfrm>
        <a:graphic>
          <a:graphicData uri="http://schemas.openxmlformats.org/drawingml/2006/table">
            <a:tbl>
              <a:tblPr firstRow="1" firstCol="1" bandRow="1"/>
              <a:tblGrid>
                <a:gridCol w="2763481">
                  <a:extLst>
                    <a:ext uri="{9D8B030D-6E8A-4147-A177-3AD203B41FA5}">
                      <a16:colId xmlns:a16="http://schemas.microsoft.com/office/drawing/2014/main" val="3110923826"/>
                    </a:ext>
                  </a:extLst>
                </a:gridCol>
                <a:gridCol w="2147457">
                  <a:extLst>
                    <a:ext uri="{9D8B030D-6E8A-4147-A177-3AD203B41FA5}">
                      <a16:colId xmlns:a16="http://schemas.microsoft.com/office/drawing/2014/main" val="1207545706"/>
                    </a:ext>
                  </a:extLst>
                </a:gridCol>
                <a:gridCol w="3219785">
                  <a:extLst>
                    <a:ext uri="{9D8B030D-6E8A-4147-A177-3AD203B41FA5}">
                      <a16:colId xmlns:a16="http://schemas.microsoft.com/office/drawing/2014/main" val="3552690991"/>
                    </a:ext>
                  </a:extLst>
                </a:gridCol>
              </a:tblGrid>
              <a:tr h="214509">
                <a:tc>
                  <a:txBody>
                    <a:bodyPr/>
                    <a:lstStyle/>
                    <a:p>
                      <a:pPr algn="just" fontAlgn="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1" i="0" u="none" strike="noStrike" kern="5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Parameters</a:t>
                      </a:r>
                      <a:endParaRPr lang="en-GB" sz="1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581" marR="61581" marT="85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1" i="0" u="none" strike="noStrike" kern="5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Pat.’s values</a:t>
                      </a:r>
                      <a:endParaRPr lang="en-GB" sz="1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581" marR="61581" marT="85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1" i="0" u="none" strike="noStrike" kern="5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Age-matched reference range</a:t>
                      </a:r>
                      <a:endParaRPr lang="en-GB" sz="1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581" marR="61581" marT="85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93439543"/>
                  </a:ext>
                </a:extLst>
              </a:tr>
              <a:tr h="288065">
                <a:tc gridSpan="3">
                  <a:txBody>
                    <a:bodyPr/>
                    <a:lstStyle/>
                    <a:p>
                      <a:pPr algn="just" fontAlgn="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1" i="0" u="none" strike="noStrike" kern="5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Full blood count:</a:t>
                      </a:r>
                      <a:endParaRPr lang="en-GB" sz="1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109" marR="82109" marT="41054" marB="41054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44014884"/>
                  </a:ext>
                </a:extLst>
              </a:tr>
              <a:tr h="214509">
                <a:tc>
                  <a:txBody>
                    <a:bodyPr/>
                    <a:lstStyle/>
                    <a:p>
                      <a:pPr algn="just" fontAlgn="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i="0" u="none" strike="noStrike" kern="5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hemoglobin</a:t>
                      </a:r>
                      <a:endParaRPr lang="en-GB" sz="1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581" marR="61581" marT="85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 kern="50"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6.20 mmol/l</a:t>
                      </a:r>
                      <a:endParaRPr lang="en-US" sz="1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581" marR="61581" marT="85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i="0" u="none" strike="noStrike" kern="5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6.50-8.00 mmol/l</a:t>
                      </a:r>
                      <a:endParaRPr lang="en-GB" sz="1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581" marR="61581" marT="85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93547267"/>
                  </a:ext>
                </a:extLst>
              </a:tr>
              <a:tr h="214509">
                <a:tc>
                  <a:txBody>
                    <a:bodyPr/>
                    <a:lstStyle/>
                    <a:p>
                      <a:pPr algn="just" fontAlgn="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b="0" i="0" u="none" strike="noStrike" kern="50"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hematocrit</a:t>
                      </a:r>
                      <a:endParaRPr lang="de-DE" sz="1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581" marR="61581" marT="85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b="0" i="0" u="none" strike="noStrike" kern="50"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0.34</a:t>
                      </a:r>
                      <a:endParaRPr lang="de-DE" sz="1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581" marR="61581" marT="85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b="0" i="0" u="none" strike="noStrike" kern="50"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0.35-0.43</a:t>
                      </a:r>
                      <a:endParaRPr lang="de-DE" sz="1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581" marR="61581" marT="85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62554150"/>
                  </a:ext>
                </a:extLst>
              </a:tr>
              <a:tr h="214509">
                <a:tc>
                  <a:txBody>
                    <a:bodyPr/>
                    <a:lstStyle/>
                    <a:p>
                      <a:pPr algn="just" fontAlgn="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i="0" u="none" strike="noStrike" kern="5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white cell count</a:t>
                      </a:r>
                      <a:endParaRPr lang="en-GB" sz="1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581" marR="61581" marT="85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b="0" i="0" u="none" strike="noStrike" kern="50"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8,460</a:t>
                      </a:r>
                      <a:r>
                        <a:rPr lang="de-DE" sz="1000" b="0" i="0" u="none" strike="noStrike" kern="5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/µl</a:t>
                      </a:r>
                      <a:endParaRPr lang="de-DE" sz="1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581" marR="61581" marT="85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i="0" u="none" strike="noStrike" kern="5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6,000-17,500/µl</a:t>
                      </a:r>
                      <a:endParaRPr lang="en-GB" sz="1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581" marR="61581" marT="85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26637000"/>
                  </a:ext>
                </a:extLst>
              </a:tr>
              <a:tr h="214509">
                <a:tc>
                  <a:txBody>
                    <a:bodyPr/>
                    <a:lstStyle/>
                    <a:p>
                      <a:pPr algn="just" fontAlgn="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i="0" u="none" strike="noStrike" kern="5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platelet count</a:t>
                      </a:r>
                      <a:endParaRPr lang="en-GB" sz="1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581" marR="61581" marT="85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b="0" i="0" u="none" strike="noStrike" kern="50"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459,000</a:t>
                      </a:r>
                      <a:r>
                        <a:rPr lang="de-DE" sz="1000" b="0" i="0" u="none" strike="noStrike" kern="5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/µl</a:t>
                      </a:r>
                      <a:endParaRPr lang="de-DE" sz="1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581" marR="61581" marT="85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i="0" u="none" strike="noStrike" kern="5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150,000-400,000/µl</a:t>
                      </a:r>
                      <a:endParaRPr lang="en-GB" sz="1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581" marR="61581" marT="85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4316040"/>
                  </a:ext>
                </a:extLst>
              </a:tr>
              <a:tr h="461177">
                <a:tc gridSpan="3">
                  <a:txBody>
                    <a:bodyPr/>
                    <a:lstStyle/>
                    <a:p>
                      <a:pPr algn="just" fontAlgn="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i="1" u="none" strike="noStrike" kern="5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Normal values for:</a:t>
                      </a:r>
                      <a:r>
                        <a:rPr lang="en-GB" sz="1000" b="0" i="0" u="none" strike="noStrike" kern="5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 </a:t>
                      </a:r>
                      <a:endParaRPr lang="en-GB" sz="1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  <a:p>
                      <a:pPr algn="just" fontAlgn="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i="0" u="none" strike="noStrike" kern="5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differential white cell count</a:t>
                      </a:r>
                      <a:endParaRPr lang="en-GB" sz="1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109" marR="82109" marT="41054" marB="41054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25050861"/>
                  </a:ext>
                </a:extLst>
              </a:tr>
              <a:tr h="288065">
                <a:tc gridSpan="3">
                  <a:txBody>
                    <a:bodyPr/>
                    <a:lstStyle/>
                    <a:p>
                      <a:pPr algn="just" fontAlgn="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1" i="0" u="none" strike="noStrike" kern="5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Blood chemistry:</a:t>
                      </a:r>
                      <a:endParaRPr lang="en-GB" sz="1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109" marR="82109" marT="41054" marB="41054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67415473"/>
                  </a:ext>
                </a:extLst>
              </a:tr>
              <a:tr h="214509">
                <a:tc>
                  <a:txBody>
                    <a:bodyPr/>
                    <a:lstStyle/>
                    <a:p>
                      <a:pPr algn="just" fontAlgn="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b="0" i="0" u="none" strike="noStrike" kern="50"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CrP</a:t>
                      </a:r>
                      <a:endParaRPr lang="de-DE" sz="1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581" marR="61581" marT="85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b="0" i="0" u="none" strike="noStrike" kern="50"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14.5 mg/l</a:t>
                      </a:r>
                      <a:endParaRPr lang="de-DE" sz="1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581" marR="61581" marT="85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b="0" i="0" u="none" strike="noStrike" kern="50">
                          <a:effectLst/>
                          <a:latin typeface="Arial" panose="020B0604020202020204" pitchFamily="34" charset="0"/>
                          <a:ea typeface="SimSun" panose="02010600030101010101" pitchFamily="2" charset="-122"/>
                        </a:rPr>
                        <a:t>&lt;5 mg/l</a:t>
                      </a:r>
                      <a:endParaRPr lang="de-DE" sz="1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581" marR="61581" marT="85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22754340"/>
                  </a:ext>
                </a:extLst>
              </a:tr>
              <a:tr h="214509">
                <a:tc>
                  <a:txBody>
                    <a:bodyPr/>
                    <a:lstStyle/>
                    <a:p>
                      <a:pPr algn="just" fontAlgn="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b="0" i="0" u="none" strike="noStrike" kern="50"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LDH</a:t>
                      </a:r>
                      <a:endParaRPr lang="de-DE" sz="1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581" marR="61581" marT="85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b="0" i="0" u="none" strike="noStrike" kern="50" dirty="0"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8.09 </a:t>
                      </a:r>
                      <a:r>
                        <a:rPr lang="de-DE" sz="1000" b="0" i="0" u="none" strike="noStrike" kern="5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µ</a:t>
                      </a:r>
                      <a:r>
                        <a:rPr lang="de-DE" sz="1000" b="0" i="0" u="none" strike="noStrike" kern="5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mol</a:t>
                      </a:r>
                      <a:r>
                        <a:rPr lang="de-DE" sz="1000" b="0" i="0" u="none" strike="noStrike" kern="5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/s*l</a:t>
                      </a:r>
                      <a:endParaRPr lang="de-DE" sz="1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581" marR="61581" marT="85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b="0" i="0" u="none" strike="noStrike" kern="50" dirty="0">
                          <a:effectLst/>
                          <a:latin typeface="Arial" panose="020B0604020202020204" pitchFamily="34" charset="0"/>
                          <a:ea typeface="SimSun" panose="02010600030101010101" pitchFamily="2" charset="-122"/>
                        </a:rPr>
                        <a:t>2.00-5.00 </a:t>
                      </a:r>
                      <a:r>
                        <a:rPr lang="de-DE" sz="1000" b="0" i="0" u="none" strike="noStrike" kern="5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SimSun" panose="02010600030101010101" pitchFamily="2" charset="-122"/>
                        </a:rPr>
                        <a:t>µ</a:t>
                      </a:r>
                      <a:r>
                        <a:rPr lang="de-DE" sz="1000" b="0" i="0" u="none" strike="noStrike" kern="5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SimSun" panose="02010600030101010101" pitchFamily="2" charset="-122"/>
                        </a:rPr>
                        <a:t>mol</a:t>
                      </a:r>
                      <a:r>
                        <a:rPr lang="de-DE" sz="1000" b="0" i="0" u="none" strike="noStrike" kern="5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SimSun" panose="02010600030101010101" pitchFamily="2" charset="-122"/>
                        </a:rPr>
                        <a:t>/s*l</a:t>
                      </a:r>
                      <a:endParaRPr lang="de-DE" sz="1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581" marR="61581" marT="85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84240239"/>
                  </a:ext>
                </a:extLst>
              </a:tr>
              <a:tr h="214509">
                <a:tc>
                  <a:txBody>
                    <a:bodyPr/>
                    <a:lstStyle/>
                    <a:p>
                      <a:pPr algn="just" fontAlgn="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b="0" i="0" u="none" strike="noStrike" kern="50"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uric acid</a:t>
                      </a:r>
                      <a:endParaRPr lang="de-DE" sz="1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581" marR="61581" marT="85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b="0" i="0" u="none" strike="noStrike" kern="50"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470 </a:t>
                      </a:r>
                      <a:r>
                        <a:rPr lang="de-DE" sz="1000" b="0" i="0" u="none" strike="noStrike" kern="5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µmol/l</a:t>
                      </a:r>
                      <a:endParaRPr lang="de-DE" sz="1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581" marR="61581" marT="85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b="0" i="0" u="none" strike="noStrike" kern="50"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71-330 </a:t>
                      </a:r>
                      <a:r>
                        <a:rPr lang="de-DE" sz="1000" b="0" i="0" u="none" strike="noStrike" kern="5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µmol/l</a:t>
                      </a:r>
                      <a:endParaRPr lang="de-DE" sz="1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581" marR="61581" marT="85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61129492"/>
                  </a:ext>
                </a:extLst>
              </a:tr>
              <a:tr h="214509">
                <a:tc>
                  <a:txBody>
                    <a:bodyPr/>
                    <a:lstStyle/>
                    <a:p>
                      <a:pPr algn="just" fontAlgn="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b="0" i="0" u="none" strike="noStrike" kern="50"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albumin</a:t>
                      </a:r>
                      <a:endParaRPr lang="de-DE" sz="1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581" marR="61581" marT="85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b="0" i="0" u="none" strike="noStrike" kern="50"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28.6 g/l</a:t>
                      </a:r>
                      <a:endParaRPr lang="de-DE" sz="1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581" marR="61581" marT="85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b="0" i="0" u="none" strike="noStrike" kern="50"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38.0-54.0 g/l</a:t>
                      </a:r>
                      <a:endParaRPr lang="de-DE" sz="1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581" marR="61581" marT="85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09852345"/>
                  </a:ext>
                </a:extLst>
              </a:tr>
              <a:tr h="461177">
                <a:tc gridSpan="3">
                  <a:txBody>
                    <a:bodyPr/>
                    <a:lstStyle/>
                    <a:p>
                      <a:pPr algn="just" fontAlgn="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i="1" u="none" strike="noStrike" kern="5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Normal values for:</a:t>
                      </a:r>
                      <a:r>
                        <a:rPr lang="en-GB" sz="1000" b="0" i="0" u="none" strike="noStrike" kern="5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 </a:t>
                      </a:r>
                      <a:endParaRPr lang="en-GB" sz="1600" b="0" i="0" u="none" strike="noStrike">
                        <a:effectLst/>
                        <a:latin typeface="Arial" panose="020B0604020202020204" pitchFamily="34" charset="0"/>
                      </a:endParaRPr>
                    </a:p>
                    <a:p>
                      <a:pPr algn="just" fontAlgn="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i="0" u="none" strike="noStrike" kern="5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procalcitonin, creatinine, urea, transaminases, bilirubin, gamma-GT, alkaline phosphatase, protein, ferritin</a:t>
                      </a:r>
                      <a:endParaRPr lang="en-GB" sz="1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109" marR="82109" marT="41054" marB="41054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91169397"/>
                  </a:ext>
                </a:extLst>
              </a:tr>
              <a:tr h="288065">
                <a:tc gridSpan="3">
                  <a:txBody>
                    <a:bodyPr/>
                    <a:lstStyle/>
                    <a:p>
                      <a:pPr algn="just" fontAlgn="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b="1" i="0" u="none" strike="noStrike" kern="50" dirty="0" err="1"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Coagulation</a:t>
                      </a:r>
                      <a:r>
                        <a:rPr lang="de-DE" sz="1000" b="1" i="0" u="none" strike="noStrike" kern="50" dirty="0"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:</a:t>
                      </a:r>
                      <a:endParaRPr lang="de-DE" sz="1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109" marR="82109" marT="41054" marB="41054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37841653"/>
                  </a:ext>
                </a:extLst>
              </a:tr>
              <a:tr h="214509">
                <a:tc>
                  <a:txBody>
                    <a:bodyPr/>
                    <a:lstStyle/>
                    <a:p>
                      <a:pPr algn="just" fontAlgn="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b="0" i="0" u="none" strike="noStrike" kern="50"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prothrombin time</a:t>
                      </a:r>
                      <a:endParaRPr lang="de-DE" sz="1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581" marR="61581" marT="85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b="0" i="0" u="none" strike="noStrike" kern="50"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64%</a:t>
                      </a:r>
                      <a:endParaRPr lang="de-DE" sz="1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581" marR="61581" marT="85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b="0" i="0" u="none" strike="noStrike" kern="50"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70-120%</a:t>
                      </a:r>
                      <a:endParaRPr lang="de-DE" sz="1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581" marR="61581" marT="85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89462597"/>
                  </a:ext>
                </a:extLst>
              </a:tr>
              <a:tr h="214509">
                <a:tc>
                  <a:txBody>
                    <a:bodyPr/>
                    <a:lstStyle/>
                    <a:p>
                      <a:pPr algn="just" fontAlgn="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b="0" i="0" u="none" strike="noStrike" kern="50" dirty="0"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INR</a:t>
                      </a:r>
                      <a:endParaRPr lang="de-DE" sz="1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581" marR="61581" marT="85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b="0" i="0" u="none" strike="noStrike" kern="50"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1.34</a:t>
                      </a:r>
                      <a:endParaRPr lang="de-DE" sz="1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581" marR="61581" marT="85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b="0" i="0" u="none" strike="noStrike" kern="50"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0.9-1.2</a:t>
                      </a:r>
                      <a:endParaRPr lang="de-DE" sz="1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581" marR="61581" marT="85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55817796"/>
                  </a:ext>
                </a:extLst>
              </a:tr>
              <a:tr h="214509">
                <a:tc>
                  <a:txBody>
                    <a:bodyPr/>
                    <a:lstStyle/>
                    <a:p>
                      <a:pPr algn="just" fontAlgn="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b="0" i="0" u="none" strike="noStrike" kern="50" dirty="0"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D-dimere</a:t>
                      </a:r>
                      <a:endParaRPr lang="de-DE" sz="1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581" marR="61581" marT="85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b="0" i="0" u="none" strike="noStrike" kern="50" dirty="0"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&gt;4000 </a:t>
                      </a:r>
                      <a:r>
                        <a:rPr lang="de-DE" sz="1000" b="0" i="0" u="none" strike="noStrike" kern="50" dirty="0" err="1"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ng</a:t>
                      </a:r>
                      <a:r>
                        <a:rPr lang="de-DE" sz="1000" b="0" i="0" u="none" strike="noStrike" kern="50" dirty="0"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/ml</a:t>
                      </a:r>
                      <a:endParaRPr lang="de-DE" sz="1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581" marR="61581" marT="85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b="0" i="0" u="none" strike="noStrike" kern="50" dirty="0"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&lt;501 </a:t>
                      </a:r>
                      <a:r>
                        <a:rPr lang="de-DE" sz="1000" b="0" i="0" u="none" strike="noStrike" kern="50" dirty="0" err="1"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ng</a:t>
                      </a:r>
                      <a:r>
                        <a:rPr lang="de-DE" sz="1000" b="0" i="0" u="none" strike="noStrike" kern="50" dirty="0"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/ml</a:t>
                      </a:r>
                      <a:endParaRPr lang="de-DE" sz="1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581" marR="61581" marT="85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673134"/>
                  </a:ext>
                </a:extLst>
              </a:tr>
              <a:tr h="461177">
                <a:tc gridSpan="3">
                  <a:txBody>
                    <a:bodyPr/>
                    <a:lstStyle/>
                    <a:p>
                      <a:pPr algn="just" fontAlgn="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i="1" u="none" strike="noStrike" kern="5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Normal values for:</a:t>
                      </a:r>
                      <a:r>
                        <a:rPr lang="en-GB" sz="1000" b="0" i="0" u="none" strike="noStrike" kern="5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 </a:t>
                      </a:r>
                      <a:endParaRPr lang="en-GB" sz="1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  <a:p>
                      <a:pPr algn="just" fontAlgn="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i="0" u="none" strike="noStrike" kern="5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aPTT</a:t>
                      </a:r>
                      <a:r>
                        <a:rPr lang="en-GB" sz="1000" b="0" i="0" u="none" strike="noStrike" kern="5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, fibrinogen, antithrombin </a:t>
                      </a:r>
                      <a:endParaRPr lang="en-GB" sz="1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109" marR="82109" marT="41054" marB="41054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3152535"/>
                  </a:ext>
                </a:extLst>
              </a:tr>
              <a:tr h="288065">
                <a:tc gridSpan="3">
                  <a:txBody>
                    <a:bodyPr/>
                    <a:lstStyle/>
                    <a:p>
                      <a:pPr algn="just" fontAlgn="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1" i="0" u="none" strike="noStrike" kern="50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Tumor</a:t>
                      </a:r>
                      <a:r>
                        <a:rPr lang="en-GB" sz="1000" b="1" i="0" u="none" strike="noStrike" kern="5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 </a:t>
                      </a:r>
                      <a:r>
                        <a:rPr lang="en-GB" sz="1000" b="1" i="0" u="none" strike="noStrike" kern="5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markers:</a:t>
                      </a:r>
                      <a:endParaRPr lang="en-GB" sz="1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109" marR="82109" marT="41054" marB="41054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24542024"/>
                  </a:ext>
                </a:extLst>
              </a:tr>
              <a:tr h="461177">
                <a:tc gridSpan="3">
                  <a:txBody>
                    <a:bodyPr/>
                    <a:lstStyle/>
                    <a:p>
                      <a:pPr algn="just" fontAlgn="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i="1" u="none" strike="noStrike" kern="5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Normal values for:</a:t>
                      </a:r>
                      <a:r>
                        <a:rPr lang="en-GB" sz="1000" b="0" i="0" u="none" strike="noStrike" kern="5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 </a:t>
                      </a:r>
                      <a:endParaRPr lang="en-GB" sz="1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  <a:p>
                      <a:pPr algn="just" fontAlgn="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i="0" u="none" strike="noStrike" kern="5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alpha-fetoprotein, neuron-specific enolase, beta-HCG</a:t>
                      </a:r>
                      <a:endParaRPr lang="en-GB" sz="1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109" marR="82109" marT="41054" marB="41054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33254119"/>
                  </a:ext>
                </a:extLst>
              </a:tr>
            </a:tbl>
          </a:graphicData>
        </a:graphic>
      </p:graphicFrame>
      <p:sp>
        <p:nvSpPr>
          <p:cNvPr id="7" name="Textfeld 6">
            <a:extLst>
              <a:ext uri="{FF2B5EF4-FFF2-40B4-BE49-F238E27FC236}">
                <a16:creationId xmlns:a16="http://schemas.microsoft.com/office/drawing/2014/main" id="{F16B8A86-8392-2446-BC73-95E9D1E1BE3E}"/>
              </a:ext>
            </a:extLst>
          </p:cNvPr>
          <p:cNvSpPr txBox="1"/>
          <p:nvPr/>
        </p:nvSpPr>
        <p:spPr>
          <a:xfrm>
            <a:off x="222422" y="189470"/>
            <a:ext cx="40530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Table S1</a:t>
            </a:r>
          </a:p>
        </p:txBody>
      </p:sp>
    </p:spTree>
    <p:extLst>
      <p:ext uri="{BB962C8B-B14F-4D97-AF65-F5344CB8AC3E}">
        <p14:creationId xmlns:p14="http://schemas.microsoft.com/office/powerpoint/2010/main" val="106362459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6" name="Tabelle 4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11430887"/>
              </p:ext>
            </p:extLst>
          </p:nvPr>
        </p:nvGraphicFramePr>
        <p:xfrm>
          <a:off x="435944" y="797689"/>
          <a:ext cx="6489700" cy="1847850"/>
        </p:xfrm>
        <a:graphic>
          <a:graphicData uri="http://schemas.openxmlformats.org/drawingml/2006/table">
            <a:tbl>
              <a:tblPr/>
              <a:tblGrid>
                <a:gridCol w="628958">
                  <a:extLst>
                    <a:ext uri="{9D8B030D-6E8A-4147-A177-3AD203B41FA5}">
                      <a16:colId xmlns:a16="http://schemas.microsoft.com/office/drawing/2014/main" val="3438835943"/>
                    </a:ext>
                  </a:extLst>
                </a:gridCol>
                <a:gridCol w="1324623">
                  <a:extLst>
                    <a:ext uri="{9D8B030D-6E8A-4147-A177-3AD203B41FA5}">
                      <a16:colId xmlns:a16="http://schemas.microsoft.com/office/drawing/2014/main" val="33441123"/>
                    </a:ext>
                  </a:extLst>
                </a:gridCol>
                <a:gridCol w="952966">
                  <a:extLst>
                    <a:ext uri="{9D8B030D-6E8A-4147-A177-3AD203B41FA5}">
                      <a16:colId xmlns:a16="http://schemas.microsoft.com/office/drawing/2014/main" val="3375944781"/>
                    </a:ext>
                  </a:extLst>
                </a:gridCol>
                <a:gridCol w="1372271">
                  <a:extLst>
                    <a:ext uri="{9D8B030D-6E8A-4147-A177-3AD203B41FA5}">
                      <a16:colId xmlns:a16="http://schemas.microsoft.com/office/drawing/2014/main" val="2631665563"/>
                    </a:ext>
                  </a:extLst>
                </a:gridCol>
                <a:gridCol w="1232503">
                  <a:extLst>
                    <a:ext uri="{9D8B030D-6E8A-4147-A177-3AD203B41FA5}">
                      <a16:colId xmlns:a16="http://schemas.microsoft.com/office/drawing/2014/main" val="2066890083"/>
                    </a:ext>
                  </a:extLst>
                </a:gridCol>
                <a:gridCol w="978379">
                  <a:extLst>
                    <a:ext uri="{9D8B030D-6E8A-4147-A177-3AD203B41FA5}">
                      <a16:colId xmlns:a16="http://schemas.microsoft.com/office/drawing/2014/main" val="2690629834"/>
                    </a:ext>
                  </a:extLst>
                </a:gridCol>
              </a:tblGrid>
              <a:tr h="190500">
                <a:tc gridSpan="2">
                  <a:txBody>
                    <a:bodyPr/>
                    <a:lstStyle/>
                    <a:p>
                      <a:pPr algn="l" fontAlgn="b"/>
                      <a:r>
                        <a:rPr lang="de-DE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PSR VU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431524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40675929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ene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nsequenc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BSNP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ucleotide Chang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in Chang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ansmissio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36340508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GFR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ssense</a:t>
                      </a:r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varian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s36889293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.3454G&gt;C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.Asp1152His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other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87136261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ALB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ssense</a:t>
                      </a:r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varian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s73088187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.3235G&gt;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.Ala1079Ser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ather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39416019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ANCC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ssense</a:t>
                      </a:r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varian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s180036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.77C&gt;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.Ser26Ph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other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56318291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SC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ssense varian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s138138479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.4527_4529del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.Phe1510del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ather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37255188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TPN1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ssense varian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s76952345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.3239G&gt;C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.Arg1080Thr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ather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98711302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DM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ssense varian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s6105179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.2440A&gt;C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.Ser814Arg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other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53419063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35276815"/>
                  </a:ext>
                </a:extLst>
              </a:tr>
            </a:tbl>
          </a:graphicData>
        </a:graphic>
      </p:graphicFrame>
      <p:sp>
        <p:nvSpPr>
          <p:cNvPr id="47" name="Textfeld 46"/>
          <p:cNvSpPr txBox="1"/>
          <p:nvPr/>
        </p:nvSpPr>
        <p:spPr>
          <a:xfrm>
            <a:off x="222422" y="189470"/>
            <a:ext cx="40530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Table S2</a:t>
            </a:r>
          </a:p>
        </p:txBody>
      </p:sp>
    </p:spTree>
    <p:extLst>
      <p:ext uri="{BB962C8B-B14F-4D97-AF65-F5344CB8AC3E}">
        <p14:creationId xmlns:p14="http://schemas.microsoft.com/office/powerpoint/2010/main" val="36021169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2</Words>
  <Application>Microsoft Office PowerPoint</Application>
  <PresentationFormat>Breitbild</PresentationFormat>
  <Paragraphs>102</Paragraphs>
  <Slides>5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5</vt:i4>
      </vt:variant>
    </vt:vector>
  </HeadingPairs>
  <TitlesOfParts>
    <vt:vector size="10" baseType="lpstr">
      <vt:lpstr>SimSun</vt:lpstr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ngelina Beer</dc:creator>
  <cp:lastModifiedBy>Auer, Franziska</cp:lastModifiedBy>
  <cp:revision>34</cp:revision>
  <dcterms:created xsi:type="dcterms:W3CDTF">2020-11-22T17:15:44Z</dcterms:created>
  <dcterms:modified xsi:type="dcterms:W3CDTF">2021-05-10T08:28:23Z</dcterms:modified>
</cp:coreProperties>
</file>